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70F374C-B473-4892-9214-CE4561992545}" v="1" dt="2025-12-07T15:14:25.0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826" y="4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maculada Navarro Lérida" userId="a709f962-7a6b-4e29-94b4-34e94bec1ace" providerId="ADAL" clId="{CB1B0F86-67B5-48D7-A333-4A72740E5CDB}"/>
    <pc:docChg chg="undo custSel modSld">
      <pc:chgData name="Inmaculada Navarro Lérida" userId="a709f962-7a6b-4e29-94b4-34e94bec1ace" providerId="ADAL" clId="{CB1B0F86-67B5-48D7-A333-4A72740E5CDB}" dt="2025-12-07T15:14:28.449" v="30" actId="20577"/>
      <pc:docMkLst>
        <pc:docMk/>
      </pc:docMkLst>
      <pc:sldChg chg="addSp modSp mod">
        <pc:chgData name="Inmaculada Navarro Lérida" userId="a709f962-7a6b-4e29-94b4-34e94bec1ace" providerId="ADAL" clId="{CB1B0F86-67B5-48D7-A333-4A72740E5CDB}" dt="2025-12-07T15:14:28.449" v="30" actId="20577"/>
        <pc:sldMkLst>
          <pc:docMk/>
          <pc:sldMk cId="3090598377" sldId="256"/>
        </pc:sldMkLst>
        <pc:spChg chg="add mod">
          <ac:chgData name="Inmaculada Navarro Lérida" userId="a709f962-7a6b-4e29-94b4-34e94bec1ace" providerId="ADAL" clId="{CB1B0F86-67B5-48D7-A333-4A72740E5CDB}" dt="2025-12-07T15:14:28.449" v="30" actId="20577"/>
          <ac:spMkLst>
            <pc:docMk/>
            <pc:sldMk cId="3090598377" sldId="256"/>
            <ac:spMk id="2" creationId="{E6F2F7DE-4378-489E-BDE4-8C6B20C306B0}"/>
          </ac:spMkLst>
        </pc:spChg>
        <pc:spChg chg="mod">
          <ac:chgData name="Inmaculada Navarro Lérida" userId="a709f962-7a6b-4e29-94b4-34e94bec1ace" providerId="ADAL" clId="{CB1B0F86-67B5-48D7-A333-4A72740E5CDB}" dt="2025-12-07T15:13:19.948" v="7" actId="692"/>
          <ac:spMkLst>
            <pc:docMk/>
            <pc:sldMk cId="3090598377" sldId="256"/>
            <ac:spMk id="6" creationId="{854499B5-6F4C-6A51-0E14-E4996B9FB85B}"/>
          </ac:spMkLst>
        </pc:spChg>
        <pc:spChg chg="mod">
          <ac:chgData name="Inmaculada Navarro Lérida" userId="a709f962-7a6b-4e29-94b4-34e94bec1ace" providerId="ADAL" clId="{CB1B0F86-67B5-48D7-A333-4A72740E5CDB}" dt="2025-12-07T15:13:27.935" v="8" actId="692"/>
          <ac:spMkLst>
            <pc:docMk/>
            <pc:sldMk cId="3090598377" sldId="256"/>
            <ac:spMk id="29" creationId="{C0E980D6-62A8-7CEC-9448-E8622D12DDDC}"/>
          </ac:spMkLst>
        </pc:spChg>
        <pc:grpChg chg="mod">
          <ac:chgData name="Inmaculada Navarro Lérida" userId="a709f962-7a6b-4e29-94b4-34e94bec1ace" providerId="ADAL" clId="{CB1B0F86-67B5-48D7-A333-4A72740E5CDB}" dt="2025-12-07T15:13:50.248" v="15" actId="1076"/>
          <ac:grpSpMkLst>
            <pc:docMk/>
            <pc:sldMk cId="3090598377" sldId="256"/>
            <ac:grpSpMk id="28" creationId="{27A355CC-6FFE-5596-3522-6F83F7B3AF77}"/>
          </ac:grpSpMkLst>
        </pc:grpChg>
        <pc:grpChg chg="mod">
          <ac:chgData name="Inmaculada Navarro Lérida" userId="a709f962-7a6b-4e29-94b4-34e94bec1ace" providerId="ADAL" clId="{CB1B0F86-67B5-48D7-A333-4A72740E5CDB}" dt="2025-12-07T15:13:40.918" v="14" actId="14100"/>
          <ac:grpSpMkLst>
            <pc:docMk/>
            <pc:sldMk cId="3090598377" sldId="256"/>
            <ac:grpSpMk id="31" creationId="{69B06F0A-D652-7B2E-EC1C-3F62A90FA761}"/>
          </ac:grpSpMkLst>
        </pc:grpChg>
        <pc:grpChg chg="mod">
          <ac:chgData name="Inmaculada Navarro Lérida" userId="a709f962-7a6b-4e29-94b4-34e94bec1ace" providerId="ADAL" clId="{CB1B0F86-67B5-48D7-A333-4A72740E5CDB}" dt="2025-12-07T15:14:18.950" v="20" actId="1076"/>
          <ac:grpSpMkLst>
            <pc:docMk/>
            <pc:sldMk cId="3090598377" sldId="256"/>
            <ac:grpSpMk id="49" creationId="{EDE4DAC9-DD0D-BE30-D0F9-7F3797EFAF62}"/>
          </ac:grpSpMkLst>
        </pc:grpChg>
        <pc:grpChg chg="mod">
          <ac:chgData name="Inmaculada Navarro Lérida" userId="a709f962-7a6b-4e29-94b4-34e94bec1ace" providerId="ADAL" clId="{CB1B0F86-67B5-48D7-A333-4A72740E5CDB}" dt="2025-12-07T15:14:03.649" v="18" actId="14100"/>
          <ac:grpSpMkLst>
            <pc:docMk/>
            <pc:sldMk cId="3090598377" sldId="256"/>
            <ac:grpSpMk id="78" creationId="{5D3BB01C-224F-3714-9A45-42CCA8F1A145}"/>
          </ac:grpSpMkLst>
        </pc:grpChg>
        <pc:picChg chg="mod modCrop">
          <ac:chgData name="Inmaculada Navarro Lérida" userId="a709f962-7a6b-4e29-94b4-34e94bec1ace" providerId="ADAL" clId="{CB1B0F86-67B5-48D7-A333-4A72740E5CDB}" dt="2025-12-07T15:12:16.448" v="2" actId="732"/>
          <ac:picMkLst>
            <pc:docMk/>
            <pc:sldMk cId="3090598377" sldId="256"/>
            <ac:picMk id="5" creationId="{CF1561E7-B4D0-5631-B1EF-75B702B1221B}"/>
          </ac:picMkLst>
        </pc:picChg>
        <pc:picChg chg="mod modCrop">
          <ac:chgData name="Inmaculada Navarro Lérida" userId="a709f962-7a6b-4e29-94b4-34e94bec1ace" providerId="ADAL" clId="{CB1B0F86-67B5-48D7-A333-4A72740E5CDB}" dt="2025-12-07T15:13:33.947" v="12" actId="1076"/>
          <ac:picMkLst>
            <pc:docMk/>
            <pc:sldMk cId="3090598377" sldId="256"/>
            <ac:picMk id="18" creationId="{DB26698B-ADFD-4424-2914-A264AB228065}"/>
          </ac:picMkLst>
        </pc:picChg>
        <pc:picChg chg="mod modCrop">
          <ac:chgData name="Inmaculada Navarro Lérida" userId="a709f962-7a6b-4e29-94b4-34e94bec1ace" providerId="ADAL" clId="{CB1B0F86-67B5-48D7-A333-4A72740E5CDB}" dt="2025-12-07T15:14:14.569" v="19" actId="732"/>
          <ac:picMkLst>
            <pc:docMk/>
            <pc:sldMk cId="3090598377" sldId="256"/>
            <ac:picMk id="33" creationId="{50353EBA-681A-7B57-C980-7FE0AFBBAC2D}"/>
          </ac:picMkLst>
        </pc:picChg>
        <pc:picChg chg="mod modCrop">
          <ac:chgData name="Inmaculada Navarro Lérida" userId="a709f962-7a6b-4e29-94b4-34e94bec1ace" providerId="ADAL" clId="{CB1B0F86-67B5-48D7-A333-4A72740E5CDB}" dt="2025-12-07T15:13:59.575" v="16" actId="732"/>
          <ac:picMkLst>
            <pc:docMk/>
            <pc:sldMk cId="3090598377" sldId="256"/>
            <ac:picMk id="48" creationId="{0778C071-3AC8-3422-F215-EBEB7D6323E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31F6CF-97C1-D522-9313-FDE62695A1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B5430F8-6C5F-A9A5-6EF4-C63515A443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BF931AC-3AC4-7781-1806-E1DB664B4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5BBE08E-D3D0-A29B-6A3E-DCFA289AE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5692AF-F5C1-FF7E-42D8-83FE1BABD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6025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C23AB7-AF54-5E65-6ED3-73F1048C6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D794E00-375D-3D40-CBDB-D4FDC298A7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5793FF7-C089-0F1F-8D55-72F5D852F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BFFFDE9-999F-0CA0-7337-E33CD8F07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159ACC1-8676-5D83-2345-66046B199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0884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41D3305-E29E-3BD1-FBF1-96DD9857D4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35B76C9-BFC9-C95A-2709-75955BAF0B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A927627-5D28-FB46-A738-90C641A8D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4886C6-A3D1-FFB9-62C2-21DD0B80C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ADC3FD4-39A1-5B1F-1494-9BD60FBE4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4347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AC0AEE5-D1EA-D2F4-DB8A-CFD8E549E8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19294BD-EE9C-70E9-9F7A-39011EBD98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4AB8FD8-4DF0-0E91-D75A-7B9FC15F7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E9CEDE-D58C-CFA0-9485-8A36EEA14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3F17EC5-EA17-57A4-2C1B-ABB07158F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2449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443478-F49D-C804-8468-74AA41A180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3A549DB-351D-62CF-D0CD-20AC9D0D0B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5CB5168-C2A6-69ED-A3FF-8A43A6B77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E591B48-21EE-358C-B82B-C76886A4A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A86D3A9-F2C4-2565-23D6-469A078FC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1281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9A597A-167A-EA83-7761-D937CAE38D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16684B1-2F77-714B-52A1-DFCC6E5390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D61EB39-2F72-F57B-6B63-D7D00F65FC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7BEE194-EE9E-6440-6073-2028D622B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852FF09-AF48-77C8-4E91-612241DA4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66E49B3-0353-8784-BDD5-D0D7768CB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8330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CF2F89-C873-C26D-B2B3-330B2DC082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633A438-F19C-F2FB-AD27-F32E87D628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6D94B89-B929-F94B-085B-014E3FDF4B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9434BC5-B620-4594-799F-D8A2860C2E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FA4BB00-B701-1984-0D57-4B3B339055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9EB2D0B-AF49-5468-C4BE-CE631E009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3C929D7-231E-856D-DF3C-4A74D3472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436B3F1-498C-D345-FF95-6A6545FAE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8877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0F29CDE-56EC-6ECF-0AC3-A9361EC08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10040AF-D2A1-D3B2-E709-3D6FE6E25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7082769A-30BF-8260-15F5-FFFC8354E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244CD8F-5CD0-E908-D946-A8D686567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5721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6DAACB3-9BCE-3CD3-22DB-FE2EC6EB1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6D3ABE7-AF18-F5BA-D2CB-8776F72A9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571B30B-0DF6-8C94-6B4A-35A721E8F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7147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7DF76FD-4A68-1D9E-980A-C31575C0E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DB389C8-2852-C516-B79D-B4B4ACE943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1DB96C9-9EBC-ECAB-D533-900312EDC0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CEBD06C-1CB3-4C2B-F5B4-871539CF3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83E471C-6265-879D-8A75-81E5A6A7F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DA238CA-DAEA-198A-1569-002CB9D91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749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4B792FE-7DF6-42E1-92FD-3A4235B2B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9C801E7-1EE6-6DAC-1064-8C1B237B8A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A42172D-7541-16A3-B3E7-D1F8B7AEDA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BE23461-4C2F-68CD-2D8C-51B395982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15312E2-4D1A-362A-D819-B5B2D1134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AD8A6E4-EF32-C999-1CA8-DA0B63255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4406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3C1D0CE7-662B-024A-FD58-265FA8AF0C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59F2049-0CFE-0732-357C-2A9F5F0E7B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4F591BC-414F-3090-31E7-219AC810A4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87887D-B8D7-4971-A9FA-ED4F213341B3}" type="datetimeFigureOut">
              <a:rPr lang="es-ES" smtClean="0"/>
              <a:t>07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3299BA9-4209-220F-5CF1-EF2371A89C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D74EBD8-BFB2-8243-4281-53B2EA1FA0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78752D-F184-4279-8C4A-0A4D0B7A362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8047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o 27">
            <a:extLst>
              <a:ext uri="{FF2B5EF4-FFF2-40B4-BE49-F238E27FC236}">
                <a16:creationId xmlns:a16="http://schemas.microsoft.com/office/drawing/2014/main" id="{27A355CC-6FFE-5596-3522-6F83F7B3AF77}"/>
              </a:ext>
            </a:extLst>
          </p:cNvPr>
          <p:cNvGrpSpPr/>
          <p:nvPr/>
        </p:nvGrpSpPr>
        <p:grpSpPr>
          <a:xfrm>
            <a:off x="291218" y="482251"/>
            <a:ext cx="3283687" cy="2001238"/>
            <a:chOff x="476655" y="337448"/>
            <a:chExt cx="2797056" cy="1709453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CF1561E7-B4D0-5631-B1EF-75B702B122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6340" r="25843" b="58290"/>
            <a:stretch>
              <a:fillRect/>
            </a:stretch>
          </p:blipFill>
          <p:spPr>
            <a:xfrm>
              <a:off x="476655" y="337448"/>
              <a:ext cx="2797056" cy="1709453"/>
            </a:xfrm>
            <a:prstGeom prst="rect">
              <a:avLst/>
            </a:prstGeom>
          </p:spPr>
        </p:pic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854499B5-6F4C-6A51-0E14-E4996B9FB85B}"/>
                </a:ext>
              </a:extLst>
            </p:cNvPr>
            <p:cNvSpPr/>
            <p:nvPr/>
          </p:nvSpPr>
          <p:spPr>
            <a:xfrm>
              <a:off x="1955800" y="1371600"/>
              <a:ext cx="247650" cy="139700"/>
            </a:xfrm>
            <a:prstGeom prst="rect">
              <a:avLst/>
            </a:prstGeom>
            <a:noFill/>
            <a:ln w="9525" cap="flat" cmpd="sng" algn="ctr">
              <a:solidFill>
                <a:srgbClr val="FFFF0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5"/>
            </a:fontRef>
          </p:style>
          <p:txBody>
            <a:bodyPr rtlCol="0" anchor="ctr"/>
            <a:lstStyle/>
            <a:p>
              <a:pPr algn="ctr"/>
              <a:endParaRPr lang="es-ES">
                <a:solidFill>
                  <a:srgbClr val="FFFF00"/>
                </a:solidFill>
              </a:endParaRP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CBFC4B56-34D6-EE05-6881-B3C3A864FC8E}"/>
                </a:ext>
              </a:extLst>
            </p:cNvPr>
            <p:cNvSpPr txBox="1"/>
            <p:nvPr/>
          </p:nvSpPr>
          <p:spPr>
            <a:xfrm>
              <a:off x="762001" y="1028700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50</a:t>
              </a:r>
              <a:endParaRPr lang="es-ES" sz="200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F66513BF-8B08-99DD-1CA4-93156F837DD4}"/>
                </a:ext>
              </a:extLst>
            </p:cNvPr>
            <p:cNvSpPr txBox="1"/>
            <p:nvPr/>
          </p:nvSpPr>
          <p:spPr>
            <a:xfrm>
              <a:off x="762001" y="1086044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50</a:t>
              </a:r>
              <a:endParaRPr lang="es-ES" sz="20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64634E8B-D8C1-2CAA-0696-1426D116B62C}"/>
                </a:ext>
              </a:extLst>
            </p:cNvPr>
            <p:cNvSpPr txBox="1"/>
            <p:nvPr/>
          </p:nvSpPr>
          <p:spPr>
            <a:xfrm>
              <a:off x="762001" y="1148150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00</a:t>
              </a:r>
              <a:endParaRPr lang="es-ES" sz="20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863906B9-80CA-9517-7487-BD8F5E9E32B8}"/>
                </a:ext>
              </a:extLst>
            </p:cNvPr>
            <p:cNvSpPr txBox="1"/>
            <p:nvPr/>
          </p:nvSpPr>
          <p:spPr>
            <a:xfrm>
              <a:off x="772421" y="1212637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75</a:t>
              </a:r>
              <a:endParaRPr lang="es-ES" sz="2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C712230-B182-6C9B-29CB-9BD8B5C2D824}"/>
                </a:ext>
              </a:extLst>
            </p:cNvPr>
            <p:cNvSpPr txBox="1"/>
            <p:nvPr/>
          </p:nvSpPr>
          <p:spPr>
            <a:xfrm>
              <a:off x="778079" y="1320181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50</a:t>
              </a:r>
              <a:endParaRPr lang="es-ES" sz="200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87E908EE-01DB-B8EF-31AD-1C81AC4B61AD}"/>
                </a:ext>
              </a:extLst>
            </p:cNvPr>
            <p:cNvSpPr txBox="1"/>
            <p:nvPr/>
          </p:nvSpPr>
          <p:spPr>
            <a:xfrm>
              <a:off x="782841" y="1441450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37</a:t>
              </a:r>
              <a:endParaRPr lang="es-ES" sz="200" dirty="0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CA9E1798-1239-FDB7-3DE0-ECB3BE885946}"/>
                </a:ext>
              </a:extLst>
            </p:cNvPr>
            <p:cNvSpPr txBox="1"/>
            <p:nvPr/>
          </p:nvSpPr>
          <p:spPr>
            <a:xfrm>
              <a:off x="782841" y="1646254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5</a:t>
              </a:r>
              <a:endParaRPr lang="es-ES" sz="200" dirty="0"/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3221AEEC-7B97-B9FA-A8D9-00654A367BFE}"/>
                </a:ext>
              </a:extLst>
            </p:cNvPr>
            <p:cNvSpPr txBox="1"/>
            <p:nvPr/>
          </p:nvSpPr>
          <p:spPr>
            <a:xfrm>
              <a:off x="782841" y="1769903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0</a:t>
              </a:r>
              <a:endParaRPr lang="es-ES" sz="200" dirty="0"/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A749FC7D-7C69-0D79-ACA0-DEAB5633447A}"/>
                </a:ext>
              </a:extLst>
            </p:cNvPr>
            <p:cNvSpPr txBox="1"/>
            <p:nvPr/>
          </p:nvSpPr>
          <p:spPr>
            <a:xfrm>
              <a:off x="782841" y="1908402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5</a:t>
              </a:r>
              <a:endParaRPr lang="es-ES" sz="200" dirty="0"/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B9DF3259-9BD5-96AF-9CB1-B6D56E331F6D}"/>
                </a:ext>
              </a:extLst>
            </p:cNvPr>
            <p:cNvSpPr txBox="1"/>
            <p:nvPr/>
          </p:nvSpPr>
          <p:spPr>
            <a:xfrm>
              <a:off x="2481263" y="1351136"/>
              <a:ext cx="361950" cy="2000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s-ES" sz="700" dirty="0"/>
                <a:t>G</a:t>
              </a:r>
              <a:r>
                <a:rPr lang="el-GR" sz="700" dirty="0"/>
                <a:t>α</a:t>
              </a:r>
              <a:r>
                <a:rPr lang="es-ES" sz="700" dirty="0"/>
                <a:t>q</a:t>
              </a:r>
            </a:p>
          </p:txBody>
        </p:sp>
      </p:grpSp>
      <p:grpSp>
        <p:nvGrpSpPr>
          <p:cNvPr id="31" name="Grupo 30">
            <a:extLst>
              <a:ext uri="{FF2B5EF4-FFF2-40B4-BE49-F238E27FC236}">
                <a16:creationId xmlns:a16="http://schemas.microsoft.com/office/drawing/2014/main" id="{69B06F0A-D652-7B2E-EC1C-3F62A90FA761}"/>
              </a:ext>
            </a:extLst>
          </p:cNvPr>
          <p:cNvGrpSpPr/>
          <p:nvPr/>
        </p:nvGrpSpPr>
        <p:grpSpPr>
          <a:xfrm>
            <a:off x="291218" y="2879634"/>
            <a:ext cx="3051986" cy="1811396"/>
            <a:chOff x="3569477" y="337449"/>
            <a:chExt cx="2820283" cy="1709452"/>
          </a:xfrm>
        </p:grpSpPr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id="{DB26698B-ADFD-4424-2914-A264AB2280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5874" r="25911" b="60975"/>
            <a:stretch>
              <a:fillRect/>
            </a:stretch>
          </p:blipFill>
          <p:spPr>
            <a:xfrm>
              <a:off x="3569477" y="337449"/>
              <a:ext cx="2820283" cy="1599386"/>
            </a:xfrm>
            <a:prstGeom prst="rect">
              <a:avLst/>
            </a:prstGeom>
          </p:spPr>
        </p:pic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06BBBA61-1B78-9DDA-476F-BBDE7B57BA27}"/>
                </a:ext>
              </a:extLst>
            </p:cNvPr>
            <p:cNvSpPr txBox="1"/>
            <p:nvPr/>
          </p:nvSpPr>
          <p:spPr>
            <a:xfrm>
              <a:off x="3866643" y="1028700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50</a:t>
              </a:r>
              <a:endParaRPr lang="es-ES" sz="200" dirty="0"/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954C7A75-692B-C0AE-1AFD-A0B2EA1D4C10}"/>
                </a:ext>
              </a:extLst>
            </p:cNvPr>
            <p:cNvSpPr txBox="1"/>
            <p:nvPr/>
          </p:nvSpPr>
          <p:spPr>
            <a:xfrm>
              <a:off x="3866643" y="1086044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50</a:t>
              </a:r>
              <a:endParaRPr lang="es-ES" sz="200" dirty="0"/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68B32CB6-EDE0-5149-72C0-6E0E1582C15D}"/>
                </a:ext>
              </a:extLst>
            </p:cNvPr>
            <p:cNvSpPr txBox="1"/>
            <p:nvPr/>
          </p:nvSpPr>
          <p:spPr>
            <a:xfrm>
              <a:off x="3866643" y="1148150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00</a:t>
              </a:r>
              <a:endParaRPr lang="es-ES" sz="200" dirty="0"/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AAF3E81F-656D-A86A-DA97-A5F27065D1C6}"/>
                </a:ext>
              </a:extLst>
            </p:cNvPr>
            <p:cNvSpPr txBox="1"/>
            <p:nvPr/>
          </p:nvSpPr>
          <p:spPr>
            <a:xfrm>
              <a:off x="3877063" y="1212637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75</a:t>
              </a:r>
              <a:endParaRPr lang="es-ES" sz="200" dirty="0"/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06B107CC-4438-3C1D-E0BA-C550FCB44C90}"/>
                </a:ext>
              </a:extLst>
            </p:cNvPr>
            <p:cNvSpPr txBox="1"/>
            <p:nvPr/>
          </p:nvSpPr>
          <p:spPr>
            <a:xfrm>
              <a:off x="3882721" y="1320181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50</a:t>
              </a:r>
              <a:endParaRPr lang="es-ES" sz="200" dirty="0"/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28430476-8DFA-7CE3-D723-6B11751C5F13}"/>
                </a:ext>
              </a:extLst>
            </p:cNvPr>
            <p:cNvSpPr txBox="1"/>
            <p:nvPr/>
          </p:nvSpPr>
          <p:spPr>
            <a:xfrm>
              <a:off x="3887483" y="1441450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37</a:t>
              </a:r>
              <a:endParaRPr lang="es-ES" sz="200" dirty="0"/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A348FB2C-303F-3D75-E46F-3735CCCE5021}"/>
                </a:ext>
              </a:extLst>
            </p:cNvPr>
            <p:cNvSpPr txBox="1"/>
            <p:nvPr/>
          </p:nvSpPr>
          <p:spPr>
            <a:xfrm>
              <a:off x="3887483" y="1646254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5</a:t>
              </a:r>
              <a:endParaRPr lang="es-ES" sz="200" dirty="0"/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60C0DA5-9881-B903-1F82-CE42379944C5}"/>
                </a:ext>
              </a:extLst>
            </p:cNvPr>
            <p:cNvSpPr txBox="1"/>
            <p:nvPr/>
          </p:nvSpPr>
          <p:spPr>
            <a:xfrm>
              <a:off x="3887483" y="1769903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0</a:t>
              </a:r>
              <a:endParaRPr lang="es-ES" sz="200" dirty="0"/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039A3657-7600-3EE8-FF2C-ED38E62B9699}"/>
                </a:ext>
              </a:extLst>
            </p:cNvPr>
            <p:cNvSpPr txBox="1"/>
            <p:nvPr/>
          </p:nvSpPr>
          <p:spPr>
            <a:xfrm>
              <a:off x="3887483" y="1908402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5</a:t>
              </a:r>
              <a:endParaRPr lang="es-ES" sz="200" dirty="0"/>
            </a:p>
          </p:txBody>
        </p:sp>
        <p:sp>
          <p:nvSpPr>
            <p:cNvPr id="29" name="Rectángulo 28">
              <a:extLst>
                <a:ext uri="{FF2B5EF4-FFF2-40B4-BE49-F238E27FC236}">
                  <a16:creationId xmlns:a16="http://schemas.microsoft.com/office/drawing/2014/main" id="{C0E980D6-62A8-7CEC-9448-E8622D12DDDC}"/>
                </a:ext>
              </a:extLst>
            </p:cNvPr>
            <p:cNvSpPr/>
            <p:nvPr/>
          </p:nvSpPr>
          <p:spPr>
            <a:xfrm>
              <a:off x="5080000" y="1693505"/>
              <a:ext cx="247650" cy="139700"/>
            </a:xfrm>
            <a:prstGeom prst="rect">
              <a:avLst/>
            </a:prstGeom>
            <a:noFill/>
            <a:ln w="9525" cap="flat" cmpd="sng" algn="ctr">
              <a:solidFill>
                <a:srgbClr val="FFFF0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5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50E7D889-7B01-69DC-6071-E106CBCC736C}"/>
                </a:ext>
              </a:extLst>
            </p:cNvPr>
            <p:cNvSpPr txBox="1"/>
            <p:nvPr/>
          </p:nvSpPr>
          <p:spPr>
            <a:xfrm>
              <a:off x="5623416" y="1663327"/>
              <a:ext cx="402734" cy="2000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s-ES" sz="700" dirty="0"/>
                <a:t>Cav1</a:t>
              </a:r>
            </a:p>
          </p:txBody>
        </p:sp>
      </p:grpSp>
      <p:grpSp>
        <p:nvGrpSpPr>
          <p:cNvPr id="49" name="Grupo 48">
            <a:extLst>
              <a:ext uri="{FF2B5EF4-FFF2-40B4-BE49-F238E27FC236}">
                <a16:creationId xmlns:a16="http://schemas.microsoft.com/office/drawing/2014/main" id="{EDE4DAC9-DD0D-BE30-D0F9-7F3797EFAF62}"/>
              </a:ext>
            </a:extLst>
          </p:cNvPr>
          <p:cNvGrpSpPr/>
          <p:nvPr/>
        </p:nvGrpSpPr>
        <p:grpSpPr>
          <a:xfrm>
            <a:off x="4386427" y="2819108"/>
            <a:ext cx="3022133" cy="1839147"/>
            <a:chOff x="9169867" y="337448"/>
            <a:chExt cx="3022133" cy="1839147"/>
          </a:xfrm>
        </p:grpSpPr>
        <p:pic>
          <p:nvPicPr>
            <p:cNvPr id="33" name="Imagen 32">
              <a:extLst>
                <a:ext uri="{FF2B5EF4-FFF2-40B4-BE49-F238E27FC236}">
                  <a16:creationId xmlns:a16="http://schemas.microsoft.com/office/drawing/2014/main" id="{50353EBA-681A-7B57-C980-7FE0AFBBAC2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5874" r="25739" b="55125"/>
            <a:stretch>
              <a:fillRect/>
            </a:stretch>
          </p:blipFill>
          <p:spPr>
            <a:xfrm>
              <a:off x="9169867" y="337448"/>
              <a:ext cx="2830348" cy="1839147"/>
            </a:xfrm>
            <a:prstGeom prst="rect">
              <a:avLst/>
            </a:prstGeom>
          </p:spPr>
        </p:pic>
        <p:sp>
          <p:nvSpPr>
            <p:cNvPr id="34" name="Rectángulo 33">
              <a:extLst>
                <a:ext uri="{FF2B5EF4-FFF2-40B4-BE49-F238E27FC236}">
                  <a16:creationId xmlns:a16="http://schemas.microsoft.com/office/drawing/2014/main" id="{70B9D88A-72E2-A80B-E54A-5A8CB62ED245}"/>
                </a:ext>
              </a:extLst>
            </p:cNvPr>
            <p:cNvSpPr/>
            <p:nvPr/>
          </p:nvSpPr>
          <p:spPr>
            <a:xfrm>
              <a:off x="10970561" y="1350359"/>
              <a:ext cx="297513" cy="139700"/>
            </a:xfrm>
            <a:prstGeom prst="rect">
              <a:avLst/>
            </a:prstGeom>
            <a:noFill/>
            <a:ln w="9525" cap="flat" cmpd="sng" algn="ctr">
              <a:solidFill>
                <a:schemeClr val="accent5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5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AD059005-A508-3594-D0E7-71916C28DA4D}"/>
                </a:ext>
              </a:extLst>
            </p:cNvPr>
            <p:cNvSpPr txBox="1"/>
            <p:nvPr/>
          </p:nvSpPr>
          <p:spPr>
            <a:xfrm>
              <a:off x="11644153" y="1341422"/>
              <a:ext cx="547847" cy="2000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s-ES" sz="700" dirty="0"/>
                <a:t>GAPDH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701B0F54-AA8C-0ECD-5332-4EAAAA8AC010}"/>
                </a:ext>
              </a:extLst>
            </p:cNvPr>
            <p:cNvSpPr txBox="1"/>
            <p:nvPr/>
          </p:nvSpPr>
          <p:spPr>
            <a:xfrm>
              <a:off x="9464955" y="1138250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50</a:t>
              </a:r>
              <a:endParaRPr lang="es-ES" sz="200" dirty="0"/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575A1B05-A409-8C62-E2DD-95DDD6B50C3F}"/>
                </a:ext>
              </a:extLst>
            </p:cNvPr>
            <p:cNvSpPr txBox="1"/>
            <p:nvPr/>
          </p:nvSpPr>
          <p:spPr>
            <a:xfrm>
              <a:off x="9469717" y="1259519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37</a:t>
              </a:r>
              <a:endParaRPr lang="es-ES" sz="200" dirty="0"/>
            </a:p>
          </p:txBody>
        </p:sp>
        <p:cxnSp>
          <p:nvCxnSpPr>
            <p:cNvPr id="39" name="Conector recto 38">
              <a:extLst>
                <a:ext uri="{FF2B5EF4-FFF2-40B4-BE49-F238E27FC236}">
                  <a16:creationId xmlns:a16="http://schemas.microsoft.com/office/drawing/2014/main" id="{4595E186-531D-F2E6-786E-41F94C59B23C}"/>
                </a:ext>
              </a:extLst>
            </p:cNvPr>
            <p:cNvCxnSpPr/>
            <p:nvPr/>
          </p:nvCxnSpPr>
          <p:spPr>
            <a:xfrm>
              <a:off x="9772650" y="1028700"/>
              <a:ext cx="40640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2E95798A-E5BF-6089-927C-0D0BCEE45C0C}"/>
                </a:ext>
              </a:extLst>
            </p:cNvPr>
            <p:cNvCxnSpPr/>
            <p:nvPr/>
          </p:nvCxnSpPr>
          <p:spPr>
            <a:xfrm>
              <a:off x="10229850" y="1028700"/>
              <a:ext cx="40640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9F070896-9C97-CC1F-FE17-693173A928D7}"/>
                </a:ext>
              </a:extLst>
            </p:cNvPr>
            <p:cNvCxnSpPr/>
            <p:nvPr/>
          </p:nvCxnSpPr>
          <p:spPr>
            <a:xfrm>
              <a:off x="10678461" y="1028700"/>
              <a:ext cx="40640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 recto 41">
              <a:extLst>
                <a:ext uri="{FF2B5EF4-FFF2-40B4-BE49-F238E27FC236}">
                  <a16:creationId xmlns:a16="http://schemas.microsoft.com/office/drawing/2014/main" id="{3C878A28-8E96-8587-A294-A44051EAAE6D}"/>
                </a:ext>
              </a:extLst>
            </p:cNvPr>
            <p:cNvCxnSpPr/>
            <p:nvPr/>
          </p:nvCxnSpPr>
          <p:spPr>
            <a:xfrm>
              <a:off x="11113435" y="1028700"/>
              <a:ext cx="406400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170DEADD-B63A-B8FD-D488-D53E5F20883D}"/>
                </a:ext>
              </a:extLst>
            </p:cNvPr>
            <p:cNvSpPr txBox="1"/>
            <p:nvPr/>
          </p:nvSpPr>
          <p:spPr>
            <a:xfrm>
              <a:off x="9782528" y="751701"/>
              <a:ext cx="3866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2</a:t>
              </a:r>
            </a:p>
            <a:p>
              <a:r>
                <a:rPr lang="es-ES" sz="600" dirty="0" err="1"/>
                <a:t>shCtrl</a:t>
              </a:r>
              <a:endParaRPr lang="es-ES" sz="600" dirty="0"/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BE95A9DB-7CE2-E4CD-DF3F-F06DF564E75A}"/>
                </a:ext>
              </a:extLst>
            </p:cNvPr>
            <p:cNvSpPr txBox="1"/>
            <p:nvPr/>
          </p:nvSpPr>
          <p:spPr>
            <a:xfrm>
              <a:off x="10272059" y="751701"/>
              <a:ext cx="360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2</a:t>
              </a:r>
            </a:p>
            <a:p>
              <a:r>
                <a:rPr lang="es-ES" sz="600" dirty="0" err="1"/>
                <a:t>shGq</a:t>
              </a:r>
              <a:endParaRPr lang="es-ES" sz="600" dirty="0"/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E4F34AC1-388B-FA8B-BC3A-DBE1F04E0293}"/>
                </a:ext>
              </a:extLst>
            </p:cNvPr>
            <p:cNvSpPr txBox="1"/>
            <p:nvPr/>
          </p:nvSpPr>
          <p:spPr>
            <a:xfrm>
              <a:off x="10684811" y="759251"/>
              <a:ext cx="3866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4</a:t>
              </a:r>
            </a:p>
            <a:p>
              <a:r>
                <a:rPr lang="es-ES" sz="600" dirty="0" err="1"/>
                <a:t>shCtrl</a:t>
              </a:r>
              <a:endParaRPr lang="es-ES" sz="600" dirty="0"/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CD04D385-D59B-0187-C307-07BB4ED1295D}"/>
                </a:ext>
              </a:extLst>
            </p:cNvPr>
            <p:cNvSpPr txBox="1"/>
            <p:nvPr/>
          </p:nvSpPr>
          <p:spPr>
            <a:xfrm>
              <a:off x="11174342" y="759251"/>
              <a:ext cx="360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4</a:t>
              </a:r>
            </a:p>
            <a:p>
              <a:r>
                <a:rPr lang="es-ES" sz="600" dirty="0" err="1"/>
                <a:t>shGq</a:t>
              </a:r>
              <a:endParaRPr lang="es-ES" sz="600" dirty="0"/>
            </a:p>
          </p:txBody>
        </p:sp>
      </p:grpSp>
      <p:grpSp>
        <p:nvGrpSpPr>
          <p:cNvPr id="78" name="Grupo 77">
            <a:extLst>
              <a:ext uri="{FF2B5EF4-FFF2-40B4-BE49-F238E27FC236}">
                <a16:creationId xmlns:a16="http://schemas.microsoft.com/office/drawing/2014/main" id="{5D3BB01C-224F-3714-9A45-42CCA8F1A145}"/>
              </a:ext>
            </a:extLst>
          </p:cNvPr>
          <p:cNvGrpSpPr/>
          <p:nvPr/>
        </p:nvGrpSpPr>
        <p:grpSpPr>
          <a:xfrm>
            <a:off x="4278127" y="496140"/>
            <a:ext cx="3238735" cy="2001238"/>
            <a:chOff x="6330388" y="337448"/>
            <a:chExt cx="2783854" cy="1599385"/>
          </a:xfrm>
        </p:grpSpPr>
        <p:pic>
          <p:nvPicPr>
            <p:cNvPr id="48" name="Imagen 47">
              <a:extLst>
                <a:ext uri="{FF2B5EF4-FFF2-40B4-BE49-F238E27FC236}">
                  <a16:creationId xmlns:a16="http://schemas.microsoft.com/office/drawing/2014/main" id="{0778C071-3AC8-3422-F215-EBEB7D6323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8" r="1418" b="60975"/>
            <a:stretch>
              <a:fillRect/>
            </a:stretch>
          </p:blipFill>
          <p:spPr>
            <a:xfrm>
              <a:off x="6330388" y="337448"/>
              <a:ext cx="2783854" cy="1599385"/>
            </a:xfrm>
            <a:prstGeom prst="rect">
              <a:avLst/>
            </a:prstGeom>
          </p:spPr>
        </p:pic>
        <p:sp>
          <p:nvSpPr>
            <p:cNvPr id="50" name="Rectángulo 49">
              <a:extLst>
                <a:ext uri="{FF2B5EF4-FFF2-40B4-BE49-F238E27FC236}">
                  <a16:creationId xmlns:a16="http://schemas.microsoft.com/office/drawing/2014/main" id="{208784FF-B3CB-EF0D-73A7-E540A90F1465}"/>
                </a:ext>
              </a:extLst>
            </p:cNvPr>
            <p:cNvSpPr/>
            <p:nvPr/>
          </p:nvSpPr>
          <p:spPr>
            <a:xfrm>
              <a:off x="7772818" y="848600"/>
              <a:ext cx="263901" cy="115806"/>
            </a:xfrm>
            <a:prstGeom prst="rect">
              <a:avLst/>
            </a:prstGeom>
            <a:noFill/>
            <a:ln w="9525" cap="flat" cmpd="sng" algn="ctr">
              <a:solidFill>
                <a:schemeClr val="accent5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5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25C2DF56-81EF-EF0D-C988-5B20D935CF04}"/>
                </a:ext>
              </a:extLst>
            </p:cNvPr>
            <p:cNvSpPr txBox="1"/>
            <p:nvPr/>
          </p:nvSpPr>
          <p:spPr>
            <a:xfrm>
              <a:off x="8332504" y="797722"/>
              <a:ext cx="485953" cy="20005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s-ES" sz="700" dirty="0"/>
                <a:t>PDGFR</a:t>
              </a:r>
            </a:p>
          </p:txBody>
        </p:sp>
        <p:cxnSp>
          <p:nvCxnSpPr>
            <p:cNvPr id="54" name="Conector recto 53">
              <a:extLst>
                <a:ext uri="{FF2B5EF4-FFF2-40B4-BE49-F238E27FC236}">
                  <a16:creationId xmlns:a16="http://schemas.microsoft.com/office/drawing/2014/main" id="{60129DD7-7D00-4666-E025-28F8C490D194}"/>
                </a:ext>
              </a:extLst>
            </p:cNvPr>
            <p:cNvCxnSpPr>
              <a:cxnSpLocks/>
            </p:cNvCxnSpPr>
            <p:nvPr/>
          </p:nvCxnSpPr>
          <p:spPr>
            <a:xfrm>
              <a:off x="6841331" y="759251"/>
              <a:ext cx="345593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ector recto 54">
              <a:extLst>
                <a:ext uri="{FF2B5EF4-FFF2-40B4-BE49-F238E27FC236}">
                  <a16:creationId xmlns:a16="http://schemas.microsoft.com/office/drawing/2014/main" id="{CF49F3E5-BEEC-AE85-676D-A941A1E6B729}"/>
                </a:ext>
              </a:extLst>
            </p:cNvPr>
            <p:cNvCxnSpPr>
              <a:cxnSpLocks/>
            </p:cNvCxnSpPr>
            <p:nvPr/>
          </p:nvCxnSpPr>
          <p:spPr>
            <a:xfrm>
              <a:off x="7212133" y="759251"/>
              <a:ext cx="329286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51E477B0-FA08-87B4-EAA4-BDE9D68DFABB}"/>
                </a:ext>
              </a:extLst>
            </p:cNvPr>
            <p:cNvSpPr txBox="1"/>
            <p:nvPr/>
          </p:nvSpPr>
          <p:spPr>
            <a:xfrm>
              <a:off x="6790402" y="482252"/>
              <a:ext cx="3866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2</a:t>
              </a:r>
            </a:p>
            <a:p>
              <a:r>
                <a:rPr lang="es-ES" sz="600" dirty="0" err="1"/>
                <a:t>shCtrl</a:t>
              </a:r>
              <a:endParaRPr lang="es-ES" sz="600" dirty="0"/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2E8BE9D5-1303-E5E3-630D-680DFB819577}"/>
                </a:ext>
              </a:extLst>
            </p:cNvPr>
            <p:cNvSpPr txBox="1"/>
            <p:nvPr/>
          </p:nvSpPr>
          <p:spPr>
            <a:xfrm>
              <a:off x="7209486" y="482252"/>
              <a:ext cx="360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2</a:t>
              </a:r>
            </a:p>
            <a:p>
              <a:r>
                <a:rPr lang="es-ES" sz="600" dirty="0" err="1"/>
                <a:t>shGq</a:t>
              </a:r>
              <a:endParaRPr lang="es-ES" sz="600" dirty="0"/>
            </a:p>
          </p:txBody>
        </p:sp>
        <p:cxnSp>
          <p:nvCxnSpPr>
            <p:cNvPr id="65" name="Conector recto 64">
              <a:extLst>
                <a:ext uri="{FF2B5EF4-FFF2-40B4-BE49-F238E27FC236}">
                  <a16:creationId xmlns:a16="http://schemas.microsoft.com/office/drawing/2014/main" id="{50D79C95-BDFA-ED98-C4B2-DC9E2E8F58C3}"/>
                </a:ext>
              </a:extLst>
            </p:cNvPr>
            <p:cNvCxnSpPr>
              <a:cxnSpLocks/>
            </p:cNvCxnSpPr>
            <p:nvPr/>
          </p:nvCxnSpPr>
          <p:spPr>
            <a:xfrm>
              <a:off x="7560469" y="759251"/>
              <a:ext cx="345593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ector recto 65">
              <a:extLst>
                <a:ext uri="{FF2B5EF4-FFF2-40B4-BE49-F238E27FC236}">
                  <a16:creationId xmlns:a16="http://schemas.microsoft.com/office/drawing/2014/main" id="{6EC22D66-DD03-E2C3-8B2A-C9444C440A6B}"/>
                </a:ext>
              </a:extLst>
            </p:cNvPr>
            <p:cNvCxnSpPr>
              <a:cxnSpLocks/>
            </p:cNvCxnSpPr>
            <p:nvPr/>
          </p:nvCxnSpPr>
          <p:spPr>
            <a:xfrm>
              <a:off x="7931271" y="759251"/>
              <a:ext cx="329286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31AF1D1B-670F-2837-34A3-85DB25D55B33}"/>
                </a:ext>
              </a:extLst>
            </p:cNvPr>
            <p:cNvSpPr txBox="1"/>
            <p:nvPr/>
          </p:nvSpPr>
          <p:spPr>
            <a:xfrm>
              <a:off x="7555474" y="482252"/>
              <a:ext cx="3866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4</a:t>
              </a:r>
            </a:p>
            <a:p>
              <a:r>
                <a:rPr lang="es-ES" sz="600" dirty="0" err="1"/>
                <a:t>shCtrl</a:t>
              </a:r>
              <a:endParaRPr lang="es-ES" sz="600" dirty="0"/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675AE460-CBC6-7E3C-B4E5-D0B81CB1133A}"/>
                </a:ext>
              </a:extLst>
            </p:cNvPr>
            <p:cNvSpPr txBox="1"/>
            <p:nvPr/>
          </p:nvSpPr>
          <p:spPr>
            <a:xfrm>
              <a:off x="7919056" y="482251"/>
              <a:ext cx="360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NF4</a:t>
              </a:r>
            </a:p>
            <a:p>
              <a:r>
                <a:rPr lang="es-ES" sz="600" dirty="0" err="1"/>
                <a:t>shGq</a:t>
              </a:r>
              <a:endParaRPr lang="es-ES" sz="600" dirty="0"/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9FBE4098-8F83-8FD6-89C4-0C37071D81C2}"/>
                </a:ext>
              </a:extLst>
            </p:cNvPr>
            <p:cNvSpPr txBox="1"/>
            <p:nvPr/>
          </p:nvSpPr>
          <p:spPr>
            <a:xfrm>
              <a:off x="6552941" y="884251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50</a:t>
              </a:r>
              <a:endParaRPr lang="es-ES" sz="200" dirty="0"/>
            </a:p>
          </p:txBody>
        </p: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5085E875-DE84-A716-9694-9F82D0E427DA}"/>
                </a:ext>
              </a:extLst>
            </p:cNvPr>
            <p:cNvSpPr txBox="1"/>
            <p:nvPr/>
          </p:nvSpPr>
          <p:spPr>
            <a:xfrm>
              <a:off x="6552941" y="941595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50</a:t>
              </a:r>
              <a:endParaRPr lang="es-ES" sz="200" dirty="0"/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C9D32B57-4CEF-DA78-1C55-BE412D50ECA2}"/>
                </a:ext>
              </a:extLst>
            </p:cNvPr>
            <p:cNvSpPr txBox="1"/>
            <p:nvPr/>
          </p:nvSpPr>
          <p:spPr>
            <a:xfrm>
              <a:off x="6552941" y="1003701"/>
              <a:ext cx="24718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00</a:t>
              </a:r>
              <a:endParaRPr lang="es-ES" sz="200" dirty="0"/>
            </a:p>
          </p:txBody>
        </p: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id="{C548F03D-2F47-C807-0B11-4FD101C527CE}"/>
                </a:ext>
              </a:extLst>
            </p:cNvPr>
            <p:cNvSpPr txBox="1"/>
            <p:nvPr/>
          </p:nvSpPr>
          <p:spPr>
            <a:xfrm>
              <a:off x="6563361" y="1068188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75</a:t>
              </a:r>
              <a:endParaRPr lang="es-ES" sz="200" dirty="0"/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59AA9D7B-D7BC-CFC9-3A32-3BE84F833321}"/>
                </a:ext>
              </a:extLst>
            </p:cNvPr>
            <p:cNvSpPr txBox="1"/>
            <p:nvPr/>
          </p:nvSpPr>
          <p:spPr>
            <a:xfrm>
              <a:off x="6569019" y="1175732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50</a:t>
              </a:r>
              <a:endParaRPr lang="es-ES" sz="200" dirty="0"/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6F2A742F-F790-F786-4563-AB8D27732DFE}"/>
                </a:ext>
              </a:extLst>
            </p:cNvPr>
            <p:cNvSpPr txBox="1"/>
            <p:nvPr/>
          </p:nvSpPr>
          <p:spPr>
            <a:xfrm>
              <a:off x="6573781" y="1297001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37</a:t>
              </a:r>
              <a:endParaRPr lang="es-ES" sz="200" dirty="0"/>
            </a:p>
          </p:txBody>
        </p: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AD9E7298-F72F-B899-E7AB-93ED362BD870}"/>
                </a:ext>
              </a:extLst>
            </p:cNvPr>
            <p:cNvSpPr txBox="1"/>
            <p:nvPr/>
          </p:nvSpPr>
          <p:spPr>
            <a:xfrm>
              <a:off x="6573781" y="1501805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5</a:t>
              </a:r>
              <a:endParaRPr lang="es-ES" sz="200" dirty="0"/>
            </a:p>
          </p:txBody>
        </p: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9B4C94CC-6979-E055-C69B-4B28AF4B1901}"/>
                </a:ext>
              </a:extLst>
            </p:cNvPr>
            <p:cNvSpPr txBox="1"/>
            <p:nvPr/>
          </p:nvSpPr>
          <p:spPr>
            <a:xfrm>
              <a:off x="6573781" y="1625454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20</a:t>
              </a:r>
              <a:endParaRPr lang="es-ES" sz="200" dirty="0"/>
            </a:p>
          </p:txBody>
        </p:sp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245751B5-B4DF-E608-57EE-0CCFCEEB14F1}"/>
                </a:ext>
              </a:extLst>
            </p:cNvPr>
            <p:cNvSpPr txBox="1"/>
            <p:nvPr/>
          </p:nvSpPr>
          <p:spPr>
            <a:xfrm>
              <a:off x="6573781" y="1763953"/>
              <a:ext cx="226344" cy="138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300" dirty="0"/>
                <a:t>15</a:t>
              </a:r>
              <a:endParaRPr lang="es-ES" sz="200" dirty="0"/>
            </a:p>
          </p:txBody>
        </p: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E6F2F7DE-4378-489E-BDE4-8C6B20C306B0}"/>
              </a:ext>
            </a:extLst>
          </p:cNvPr>
          <p:cNvSpPr txBox="1"/>
          <p:nvPr/>
        </p:nvSpPr>
        <p:spPr>
          <a:xfrm>
            <a:off x="9893300" y="482251"/>
            <a:ext cx="1099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/>
              <a:t>Figure 7A</a:t>
            </a:r>
          </a:p>
        </p:txBody>
      </p:sp>
    </p:spTree>
    <p:extLst>
      <p:ext uri="{BB962C8B-B14F-4D97-AF65-F5344CB8AC3E}">
        <p14:creationId xmlns:p14="http://schemas.microsoft.com/office/powerpoint/2010/main" val="30905983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53</Words>
  <Application>Microsoft Office PowerPoint</Application>
  <PresentationFormat>Panorámica</PresentationFormat>
  <Paragraphs>5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quel Huertas Larez</dc:creator>
  <cp:lastModifiedBy>Inmaculada Navarro Lérida</cp:lastModifiedBy>
  <cp:revision>1</cp:revision>
  <dcterms:created xsi:type="dcterms:W3CDTF">2025-12-02T10:02:25Z</dcterms:created>
  <dcterms:modified xsi:type="dcterms:W3CDTF">2025-12-07T15:14:28Z</dcterms:modified>
</cp:coreProperties>
</file>